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677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07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261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693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50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271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008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802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847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450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527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A16D0-8A8E-A540-A191-317924EF07F3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5B95B-0E69-E84E-83B6-38A97AA7A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845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F79DCD9-B8D2-B249-97F0-4A8ED179BB0A}"/>
              </a:ext>
            </a:extLst>
          </p:cNvPr>
          <p:cNvSpPr txBox="1"/>
          <p:nvPr/>
        </p:nvSpPr>
        <p:spPr>
          <a:xfrm>
            <a:off x="2504560" y="8600022"/>
            <a:ext cx="203132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54AC7CE-DEE9-994D-B5B0-4E38B901D6F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58205" y="422215"/>
            <a:ext cx="3341591" cy="334159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FB62139-ECB3-5044-BE16-E6D20268C85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63721" y="4232878"/>
            <a:ext cx="34290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2858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6BEB803-BE28-9FA5-5B0C-B1EE50987ADB}"/>
              </a:ext>
            </a:extLst>
          </p:cNvPr>
          <p:cNvSpPr txBox="1"/>
          <p:nvPr/>
        </p:nvSpPr>
        <p:spPr>
          <a:xfrm>
            <a:off x="321365" y="335269"/>
            <a:ext cx="621526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6. Principal component analyses for 1</a:t>
            </a:r>
            <a:r>
              <a:rPr lang="en-US" sz="1200" b="1" dirty="0">
                <a:solidFill>
                  <a:srgbClr val="000000"/>
                </a:solidFill>
                <a:effectLst/>
                <a:latin typeface="Noto Sans Symbols"/>
                <a:ea typeface="Noto Sans Symbols"/>
                <a:cs typeface="Noto Sans Symbols"/>
              </a:rPr>
              <a:t>α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="1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="1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dependent RNA- and small RNA-Seq in African and European American Cell lines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asal and 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Noto Sans Symbols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timulated (10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8h) RNA-Seq (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 and small RNA-Seq (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 was undertaken in triplicate in HPr1AR, LNCaP, RC43N and RC43T. FASTQ files were QC processed, aligned to hg38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Rsubread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, and processed with 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limma-voo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edgeR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workflow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7309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88</Words>
  <Application>Microsoft Macintosh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Noto Sans Symbols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57:30Z</dcterms:created>
  <dcterms:modified xsi:type="dcterms:W3CDTF">2023-02-21T19:59:00Z</dcterms:modified>
</cp:coreProperties>
</file>